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58" r:id="rId2"/>
    <p:sldId id="256" r:id="rId3"/>
    <p:sldId id="269" r:id="rId4"/>
    <p:sldId id="268" r:id="rId5"/>
    <p:sldId id="267" r:id="rId6"/>
    <p:sldId id="266" r:id="rId7"/>
    <p:sldId id="270" r:id="rId8"/>
    <p:sldId id="257" r:id="rId9"/>
    <p:sldId id="27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511"/>
    <p:restoredTop sz="76463"/>
  </p:normalViewPr>
  <p:slideViewPr>
    <p:cSldViewPr snapToGrid="0">
      <p:cViewPr varScale="1">
        <p:scale>
          <a:sx n="92" d="100"/>
          <a:sy n="92" d="100"/>
        </p:scale>
        <p:origin x="9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2BF490-B2E0-4541-A5FF-426E8C1BBFFB}" type="datetimeFigureOut">
              <a:rPr lang="en-US" smtClean="0"/>
              <a:t>4/2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D97EA6-15AE-A340-9793-7D1274DDC1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719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Lateral spine X-ray (March 2022) reported proband had apparent mild anterior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beaking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of the lumbar vertebra. This was thought to be secondary to a</a:t>
            </a:r>
            <a:r>
              <a:rPr lang="en-US" sz="1200" b="0" i="0" u="none" strike="noStrike" baseline="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uperior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ossified ring apophysis.</a:t>
            </a:r>
          </a:p>
          <a:p>
            <a:pPr algn="l"/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P </a:t>
            </a:r>
            <a:r>
              <a:rPr lang="en-US" sz="12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elvis X-ray (January 2022)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</a:t>
            </a:r>
            <a:r>
              <a:rPr lang="en-US" sz="12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ported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hat the femoral ossification centers were small and </a:t>
            </a:r>
            <a:r>
              <a:rPr lang="en-US" sz="1200" b="0" i="0" u="none" strike="noStrike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tippled.</a:t>
            </a:r>
            <a:endParaRPr lang="en-US" sz="1200" b="0" i="0" u="none" strike="noStrike" dirty="0"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2012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ubular bones appear shortened, with widened </a:t>
            </a:r>
            <a:r>
              <a:rPr lang="en-US" dirty="0" err="1"/>
              <a:t>metaphyses</a:t>
            </a:r>
            <a:r>
              <a:rPr lang="en-US" dirty="0"/>
              <a:t>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9833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14 </a:t>
            </a:r>
            <a:r>
              <a:rPr lang="en-US" sz="1200" b="0" i="0" u="none" strike="noStrike" baseline="0" dirty="0" err="1">
                <a:solidFill>
                  <a:srgbClr val="1F497D"/>
                </a:solidFill>
                <a:latin typeface="CIDFont+F2"/>
              </a:rPr>
              <a:t>mo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: Platyspondyly with some wedging and anterior </a:t>
            </a:r>
            <a:r>
              <a:rPr lang="en-US" sz="1200" b="0" i="0" u="none" strike="noStrike" baseline="0" dirty="0" err="1">
                <a:solidFill>
                  <a:srgbClr val="1F497D"/>
                </a:solidFill>
                <a:latin typeface="CIDFont+F2"/>
              </a:rPr>
              <a:t>beaking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18 </a:t>
            </a:r>
            <a:r>
              <a:rPr lang="en-US" sz="1200" b="0" i="0" u="none" strike="noStrike" baseline="0" dirty="0" err="1">
                <a:solidFill>
                  <a:srgbClr val="1F497D"/>
                </a:solidFill>
                <a:latin typeface="CIDFont+F2"/>
              </a:rPr>
              <a:t>mo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: Dysplastic epiphyses and </a:t>
            </a:r>
            <a:r>
              <a:rPr lang="en-US" sz="1200" b="0" i="0" u="none" strike="noStrike" baseline="0" dirty="0" err="1">
                <a:solidFill>
                  <a:srgbClr val="1F497D"/>
                </a:solidFill>
                <a:latin typeface="CIDFont+F2"/>
              </a:rPr>
              <a:t>metaphyses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. </a:t>
            </a:r>
          </a:p>
          <a:p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3 yo: Valgus of both knees.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There is mild foreshortening of the proximal femoral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Arial" panose="020B0604020202020204" pitchFamily="34" charset="0"/>
              </a:rPr>
              <a:t>metaphyses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 with mild irregularity of the proximal metaphyseal margin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baseline="0" dirty="0">
              <a:solidFill>
                <a:srgbClr val="1F497D"/>
              </a:solidFill>
              <a:latin typeface="CIDFont+F2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9529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10 months: lateral view shows bullet-shaped vertebral bodies and anterior </a:t>
            </a:r>
            <a:r>
              <a:rPr lang="en-US" sz="1200" b="0" i="0" u="none" strike="noStrike" baseline="0" dirty="0" err="1">
                <a:solidFill>
                  <a:srgbClr val="1F497D"/>
                </a:solidFill>
                <a:latin typeface="CIDFont+F2"/>
              </a:rPr>
              <a:t>beaking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 of the upper lumbar vertebral bodie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4 yo: 12-degree thoracic curve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13 yo: S-shaped scoliosis, </a:t>
            </a:r>
            <a:r>
              <a:rPr lang="en-US" sz="1800" b="0" i="0" u="none" strike="noStrike" baseline="0" dirty="0">
                <a:latin typeface="Arial" panose="020B0604020202020204" pitchFamily="34" charset="0"/>
              </a:rPr>
              <a:t>right T3-T8 curve measuring 28 degrees and right T10-L3 curve measuring 19 degrees, and a lumbar curve of 11 degrees.</a:t>
            </a:r>
            <a:r>
              <a:rPr lang="en-US" sz="1200" b="0" i="0" u="none" strike="noStrike" baseline="0" dirty="0">
                <a:solidFill>
                  <a:srgbClr val="1F497D"/>
                </a:solidFill>
                <a:latin typeface="CIDFont+F2"/>
              </a:rPr>
              <a:t> Lateral view demonstrates platyspondyly of multiple thoracic and lumbar vertebrae with endplate irregularity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63142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Bullet-shaped vertebral bodies. Shortened tubular bones with widened </a:t>
            </a:r>
            <a:r>
              <a:rPr lang="en-US" dirty="0" err="1"/>
              <a:t>metaphyses</a:t>
            </a:r>
            <a:r>
              <a:rPr lang="en-US" dirty="0"/>
              <a:t>. Fragmented proximal epiphyses.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The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Arial" panose="020B0604020202020204" pitchFamily="34" charset="0"/>
              </a:rPr>
              <a:t>metaphyses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 of the proximal and distal femurs and proximal and distal tibias are widened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29082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rtl="0"/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18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Arial" panose="020B0604020202020204" pitchFamily="34" charset="0"/>
              </a:rPr>
              <a:t>mo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: Femoral head capital epiphyses are slightly fragmented.  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2 yo: There are slightly flared proximal femoral </a:t>
            </a:r>
            <a:r>
              <a:rPr lang="en-US" sz="1200" b="0" i="0" u="none" strike="noStrike" baseline="0" dirty="0" err="1">
                <a:solidFill>
                  <a:srgbClr val="000000"/>
                </a:solidFill>
                <a:latin typeface="Arial" panose="020B0604020202020204" pitchFamily="34" charset="0"/>
              </a:rPr>
              <a:t>metaphyses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Arial" panose="020B0604020202020204" pitchFamily="34" charset="0"/>
              </a:rPr>
              <a:t>, bilaterally, which are relatively foreshortened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60572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82587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D97EA6-15AE-A340-9793-7D1274DDC1A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9365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59ABD-392D-4F90-4AAF-D5027EDAB6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11F08C-ADC1-8216-5E1B-717389770C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216740-0413-84E3-D031-F8CB4FEE9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6F1392-56E2-3A52-89C7-06569A0B4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E893C-27D3-6D3B-E5E3-0D2B87C94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808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4E46ED-8A20-9E33-3D90-E2EA00FEC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51D314-2799-B816-FAF9-2F685EB184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B00D90-2FBA-F1FB-1A73-1580392CD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380E7A-0AB8-3801-E561-A10070158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CCCD90-BEE3-8DEB-DC17-8FC0ABF63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623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067D3B-97C8-D4E5-3A79-5B9EFF659C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4585D7-8118-564A-D2FD-2F82D47E22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643D3-3E40-3CF6-E7F0-7E031A5CA9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7FB958-BA69-821A-2146-F37DC2C51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C9725-F7FD-23F7-427C-7D596E8D0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385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3C9F3F-8F36-0634-808C-380A08A85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CF8FA9-1278-0752-B0D1-F676956391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8363D8-DEC9-B4B6-D880-EBC995D22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5213B7-0FD9-BA9D-720C-625212592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7C2BA0-66D1-CE21-1B38-015A4E276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209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9F88F6-3CD1-5356-E311-01103551E1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CA7AC2-B30C-FAD8-4479-C9460AD6C7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52D101-3AA2-54D3-C30E-A55A1011F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195143-A589-AF7D-F8E5-7E297D646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95805-E878-FA88-84DE-B226D1283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93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38EEC5-1E6C-EB22-224C-242E463F2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6A4F84-53D5-AAD7-FC1D-15B4A500CD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A5351C-1EB8-0B68-DF4F-EB06147C0B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E04059-E271-C872-A087-941A8E48D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AD1449-BEFA-B7D6-2144-4BF8EBF6B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31C386-917D-CF1B-B982-3D6BC8D7E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324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A64DF9-533B-440A-F70C-A990E5363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C6004D-E980-9737-7818-DE747B894C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1198AA-EE9A-D142-1339-95A1EF5C7D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AE4E4D-7DFC-AA51-5494-ED401A483F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DFF944-EE7B-07D6-5FD4-09F8236A28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775161-4CD7-DC25-2CE9-C21558B10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7CE5CE-3457-4A51-6946-27B72D6B5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08D2C2-6259-C907-9C32-BF80B77DD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32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4A8A46-BE65-A193-3D5C-EED686E46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CC840D-4D4A-5BC5-1DAB-F706F42AC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FEB08-A159-1EB4-6A23-D6E8F7E06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2D09C6-8941-407D-B840-1852A9187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091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CC038A-CBE1-1699-FD9E-4286BE91D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C56270-0582-BB18-EDA6-1AE86F88C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B2749A-3AE6-DAC9-47A9-EB7FF9503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609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4B557-E2C5-D1BE-FAC7-6D12DE55C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9D876E-A39B-80B7-57A4-4EF65D4323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3C6BB21-9E98-4B77-E83B-CDC33EFE16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06D625-2CB5-DA6E-FF87-487F47F8F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FFDA12-1BFA-F664-CFF9-CC9496151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2E9E3B-8AE7-8F4F-80C5-57FD0269B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718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CE8EB-5CD3-E0F7-F99B-DC3FDEAF3D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1FE259-5E24-B789-D341-B7094EE604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0FB7F5-2CEC-E500-51B2-BB9EBE88A7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57819F-0A09-651F-D264-6FC4DAD5F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8F5BC3-916C-D89F-5589-98E9E7FB2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7130D1-E11A-7E95-3F14-EE78D5192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748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39F08E-8750-EF15-EDA9-70CEFCF7A1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D87CFE-4EED-A6B5-FD63-0D3C77A3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392C5-0B35-DDE2-8C6D-B4DE375E66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EBB28-E9C4-1946-9C91-CC2898825ACC}" type="datetimeFigureOut">
              <a:rPr lang="en-US" smtClean="0"/>
              <a:t>4/25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0C438B-0AF3-1F8C-AE89-A94F8B8B60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48AAD-C502-B157-529E-EF8C63410E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26B59-A9F1-5246-9D3E-5B46C88C0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108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g"/><Relationship Id="rId5" Type="http://schemas.openxmlformats.org/officeDocument/2006/relationships/image" Target="../media/image20.png"/><Relationship Id="rId4" Type="http://schemas.openxmlformats.org/officeDocument/2006/relationships/image" Target="../media/image19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6.png"/><Relationship Id="rId7" Type="http://schemas.microsoft.com/office/2007/relationships/hdphoto" Target="../media/hdphoto2.wdp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microsoft.com/office/2007/relationships/hdphoto" Target="../media/hdphoto1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3.wdp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13" Type="http://schemas.openxmlformats.org/officeDocument/2006/relationships/image" Target="../media/image12.png"/><Relationship Id="rId18" Type="http://schemas.openxmlformats.org/officeDocument/2006/relationships/image" Target="../media/image7.jpg"/><Relationship Id="rId3" Type="http://schemas.openxmlformats.org/officeDocument/2006/relationships/image" Target="../media/image31.png"/><Relationship Id="rId21" Type="http://schemas.openxmlformats.org/officeDocument/2006/relationships/image" Target="../media/image30.png"/><Relationship Id="rId7" Type="http://schemas.openxmlformats.org/officeDocument/2006/relationships/image" Target="../media/image27.png"/><Relationship Id="rId12" Type="http://schemas.openxmlformats.org/officeDocument/2006/relationships/image" Target="../media/image15.png"/><Relationship Id="rId17" Type="http://schemas.openxmlformats.org/officeDocument/2006/relationships/image" Target="../media/image8.jpg"/><Relationship Id="rId2" Type="http://schemas.openxmlformats.org/officeDocument/2006/relationships/notesSlide" Target="../notesSlides/notesSlide8.xml"/><Relationship Id="rId16" Type="http://schemas.openxmlformats.org/officeDocument/2006/relationships/image" Target="../media/image21.jpg"/><Relationship Id="rId20" Type="http://schemas.openxmlformats.org/officeDocument/2006/relationships/image" Target="../media/image2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11.png"/><Relationship Id="rId5" Type="http://schemas.openxmlformats.org/officeDocument/2006/relationships/image" Target="../media/image3.png"/><Relationship Id="rId15" Type="http://schemas.openxmlformats.org/officeDocument/2006/relationships/image" Target="../media/image20.png"/><Relationship Id="rId10" Type="http://schemas.openxmlformats.org/officeDocument/2006/relationships/image" Target="../media/image6.jpg"/><Relationship Id="rId19" Type="http://schemas.openxmlformats.org/officeDocument/2006/relationships/image" Target="../media/image22.png"/><Relationship Id="rId4" Type="http://schemas.openxmlformats.org/officeDocument/2006/relationships/image" Target="../media/image2.jpg"/><Relationship Id="rId9" Type="http://schemas.openxmlformats.org/officeDocument/2006/relationships/image" Target="../media/image9.jpg"/><Relationship Id="rId1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7A06490-8EFE-5E1C-5433-6D69D57A4D0E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1</a:t>
            </a:r>
          </a:p>
        </p:txBody>
      </p:sp>
      <p:pic>
        <p:nvPicPr>
          <p:cNvPr id="4" name="Picture 3" descr="X-ray of a person's chest&#10;&#10;Description automatically generated">
            <a:extLst>
              <a:ext uri="{FF2B5EF4-FFF2-40B4-BE49-F238E27FC236}">
                <a16:creationId xmlns:a16="http://schemas.microsoft.com/office/drawing/2014/main" id="{7D3875C8-EDFC-7E4A-ABF8-49E6ABFDC5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7141" y="0"/>
            <a:ext cx="3439391" cy="6858000"/>
          </a:xfrm>
          <a:prstGeom prst="rect">
            <a:avLst/>
          </a:prstGeom>
        </p:spPr>
      </p:pic>
      <p:pic>
        <p:nvPicPr>
          <p:cNvPr id="6" name="Picture 5" descr="X-ray of a hip joint&#10;&#10;Description automatically generated">
            <a:extLst>
              <a:ext uri="{FF2B5EF4-FFF2-40B4-BE49-F238E27FC236}">
                <a16:creationId xmlns:a16="http://schemas.microsoft.com/office/drawing/2014/main" id="{0CD16F48-9F0D-ED78-E15C-347E244A0E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76960" y="260498"/>
            <a:ext cx="5145091" cy="2956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0376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F73599C-266A-45E0-D036-35669EDD32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8242" y="29091"/>
            <a:ext cx="1739235" cy="6858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9483F6D-5003-4534-6783-0872AC7AF7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43382" y="29091"/>
            <a:ext cx="4482285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83E31D9-6F64-D852-9EA4-814B0B8B0533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2</a:t>
            </a:r>
          </a:p>
        </p:txBody>
      </p:sp>
    </p:spTree>
    <p:extLst>
      <p:ext uri="{BB962C8B-B14F-4D97-AF65-F5344CB8AC3E}">
        <p14:creationId xmlns:p14="http://schemas.microsoft.com/office/powerpoint/2010/main" val="6909573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359F6D0-36D2-F15B-1FF3-4FD1533F60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4CA3FD-C9F0-0E85-26AF-BF631684F1A4}"/>
              </a:ext>
            </a:extLst>
          </p:cNvPr>
          <p:cNvSpPr txBox="1"/>
          <p:nvPr/>
        </p:nvSpPr>
        <p:spPr>
          <a:xfrm>
            <a:off x="212651" y="191386"/>
            <a:ext cx="2031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3 at 14 </a:t>
            </a:r>
            <a:r>
              <a:rPr lang="en-US" dirty="0" err="1"/>
              <a:t>mo</a:t>
            </a:r>
            <a:endParaRPr lang="en-US" dirty="0"/>
          </a:p>
        </p:txBody>
      </p:sp>
      <p:pic>
        <p:nvPicPr>
          <p:cNvPr id="3" name="Picture 2" descr="X-ray of a foot&#10;&#10;Description automatically generated">
            <a:extLst>
              <a:ext uri="{FF2B5EF4-FFF2-40B4-BE49-F238E27FC236}">
                <a16:creationId xmlns:a16="http://schemas.microsoft.com/office/drawing/2014/main" id="{230826C1-0F45-17BB-9102-FCCEE18B64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9470" y="3131504"/>
            <a:ext cx="5536044" cy="3389415"/>
          </a:xfrm>
          <a:prstGeom prst="rect">
            <a:avLst/>
          </a:prstGeom>
        </p:spPr>
      </p:pic>
      <p:pic>
        <p:nvPicPr>
          <p:cNvPr id="4" name="Picture 3" descr="X-ray of a human arm&#10;&#10;Description automatically generated">
            <a:extLst>
              <a:ext uri="{FF2B5EF4-FFF2-40B4-BE49-F238E27FC236}">
                <a16:creationId xmlns:a16="http://schemas.microsoft.com/office/drawing/2014/main" id="{03F05110-BF72-8D38-9B7C-69484F75D5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9470" y="560718"/>
            <a:ext cx="5536044" cy="2412804"/>
          </a:xfrm>
          <a:prstGeom prst="rect">
            <a:avLst/>
          </a:prstGeom>
        </p:spPr>
      </p:pic>
      <p:pic>
        <p:nvPicPr>
          <p:cNvPr id="5" name="Picture 4" descr="X-ray of hands and a book&#10;&#10;Description automatically generated">
            <a:extLst>
              <a:ext uri="{FF2B5EF4-FFF2-40B4-BE49-F238E27FC236}">
                <a16:creationId xmlns:a16="http://schemas.microsoft.com/office/drawing/2014/main" id="{65C1577D-7426-93A4-B268-4AB85F3D66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046" y="788612"/>
            <a:ext cx="4361451" cy="2749776"/>
          </a:xfrm>
          <a:prstGeom prst="rect">
            <a:avLst/>
          </a:prstGeom>
        </p:spPr>
      </p:pic>
      <p:pic>
        <p:nvPicPr>
          <p:cNvPr id="6" name="Picture 5" descr="X-ray of feet with toes and toes&#10;&#10;Description automatically generated">
            <a:extLst>
              <a:ext uri="{FF2B5EF4-FFF2-40B4-BE49-F238E27FC236}">
                <a16:creationId xmlns:a16="http://schemas.microsoft.com/office/drawing/2014/main" id="{C05B2B0B-4A1C-7D39-2A9E-02372098422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057" y="3766282"/>
            <a:ext cx="2694131" cy="2642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20246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370FE62-D1EF-DD9D-D0DC-28B5603934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6000B6-50B6-32AC-5F55-B9E061DBEBCB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3</a:t>
            </a:r>
          </a:p>
        </p:txBody>
      </p:sp>
      <p:pic>
        <p:nvPicPr>
          <p:cNvPr id="8" name="Picture 7" descr="X-ray of a person's body&#10;&#10;Description automatically generated">
            <a:extLst>
              <a:ext uri="{FF2B5EF4-FFF2-40B4-BE49-F238E27FC236}">
                <a16:creationId xmlns:a16="http://schemas.microsoft.com/office/drawing/2014/main" id="{451647BC-8A9C-7773-72A6-097F29F1D25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0459" y="955834"/>
            <a:ext cx="1246587" cy="462650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DEB5E2F-0C26-FDA4-CA49-55D71773BC9C}"/>
              </a:ext>
            </a:extLst>
          </p:cNvPr>
          <p:cNvSpPr txBox="1"/>
          <p:nvPr/>
        </p:nvSpPr>
        <p:spPr>
          <a:xfrm>
            <a:off x="1554863" y="5975740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 </a:t>
            </a:r>
            <a:r>
              <a:rPr lang="en-US" dirty="0" err="1"/>
              <a:t>mo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A5158CE-EC70-00A0-7FF5-8457D29FEA8B}"/>
              </a:ext>
            </a:extLst>
          </p:cNvPr>
          <p:cNvSpPr txBox="1"/>
          <p:nvPr/>
        </p:nvSpPr>
        <p:spPr>
          <a:xfrm>
            <a:off x="5007111" y="5975740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 </a:t>
            </a:r>
            <a:r>
              <a:rPr lang="en-US" dirty="0" err="1"/>
              <a:t>mo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37C40AF-0615-21A6-8F5D-679EC3FA1479}"/>
              </a:ext>
            </a:extLst>
          </p:cNvPr>
          <p:cNvSpPr txBox="1"/>
          <p:nvPr/>
        </p:nvSpPr>
        <p:spPr>
          <a:xfrm>
            <a:off x="9410964" y="5975740"/>
            <a:ext cx="577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 yo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EB9C6C5-0209-635C-DD3A-9C3D9C0DDEB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113" t="11716" r="19773" b="4526"/>
          <a:stretch/>
        </p:blipFill>
        <p:spPr>
          <a:xfrm>
            <a:off x="3323079" y="1497035"/>
            <a:ext cx="4145843" cy="354410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530BADA-DAB5-6F16-7ACF-CD1E8C816A7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5682" t="8687" r="37272" b="3028"/>
          <a:stretch/>
        </p:blipFill>
        <p:spPr>
          <a:xfrm>
            <a:off x="8335917" y="597294"/>
            <a:ext cx="2728011" cy="5009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3678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790DEB0-1D31-0641-D2B7-7AE6E86EC8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20779C-1FFE-A5D1-9D2F-D29CB261AAC6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3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DFAC546-9E27-8680-5C0D-305C9A1124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136" t="9899" r="34773" b="6262"/>
          <a:stretch/>
        </p:blipFill>
        <p:spPr>
          <a:xfrm>
            <a:off x="10333154" y="3177686"/>
            <a:ext cx="1858846" cy="363877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A025075-F861-E9A9-2CEF-8E9D328A507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452" t="9312" r="31527" b="4901"/>
          <a:stretch/>
        </p:blipFill>
        <p:spPr>
          <a:xfrm>
            <a:off x="8923378" y="30602"/>
            <a:ext cx="1630643" cy="314474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CA01D33-4337-BE76-4631-507D531EE01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3809" t="8678" r="35358" b="3068"/>
          <a:stretch/>
        </p:blipFill>
        <p:spPr>
          <a:xfrm>
            <a:off x="8951161" y="3175724"/>
            <a:ext cx="1527730" cy="364036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CA5DBEA-D382-5221-35EA-5FEA770D93A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000" t="9950" r="25348" b="4226"/>
          <a:stretch/>
        </p:blipFill>
        <p:spPr>
          <a:xfrm>
            <a:off x="10528809" y="17083"/>
            <a:ext cx="1613273" cy="315943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E871184-008A-9841-9B00-A4849CB493F3}"/>
              </a:ext>
            </a:extLst>
          </p:cNvPr>
          <p:cNvSpPr txBox="1"/>
          <p:nvPr/>
        </p:nvSpPr>
        <p:spPr>
          <a:xfrm>
            <a:off x="7852696" y="1284889"/>
            <a:ext cx="577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 yo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D526DF2-5872-9842-E4EA-2D6AF837B46D}"/>
              </a:ext>
            </a:extLst>
          </p:cNvPr>
          <p:cNvSpPr txBox="1"/>
          <p:nvPr/>
        </p:nvSpPr>
        <p:spPr>
          <a:xfrm>
            <a:off x="7716638" y="5463015"/>
            <a:ext cx="694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3 yo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C742EE2-4CEB-81C5-DBD5-43DDB2C12DC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7177" t="9319" r="12742" b="6810"/>
          <a:stretch/>
        </p:blipFill>
        <p:spPr>
          <a:xfrm rot="959940">
            <a:off x="3640602" y="999597"/>
            <a:ext cx="3670601" cy="345781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925F1DA-16BC-3D49-C127-0F1B7848B41E}"/>
              </a:ext>
            </a:extLst>
          </p:cNvPr>
          <p:cNvSpPr txBox="1"/>
          <p:nvPr/>
        </p:nvSpPr>
        <p:spPr>
          <a:xfrm>
            <a:off x="3549445" y="4429607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mo</a:t>
            </a:r>
            <a:endParaRPr lang="en-US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675F243-48BB-36B9-4B77-C6CA5E4752D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1344" t="9319" r="17339" b="4087"/>
          <a:stretch/>
        </p:blipFill>
        <p:spPr>
          <a:xfrm>
            <a:off x="33196" y="560718"/>
            <a:ext cx="3516249" cy="4145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30397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DC17A6C-A08B-7DDD-109D-F5A20B4108FD}"/>
              </a:ext>
            </a:extLst>
          </p:cNvPr>
          <p:cNvSpPr txBox="1"/>
          <p:nvPr/>
        </p:nvSpPr>
        <p:spPr>
          <a:xfrm>
            <a:off x="212651" y="191386"/>
            <a:ext cx="2031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4 at 14 </a:t>
            </a:r>
            <a:r>
              <a:rPr lang="en-US" dirty="0" err="1"/>
              <a:t>mo</a:t>
            </a:r>
            <a:endParaRPr lang="en-US" dirty="0"/>
          </a:p>
        </p:txBody>
      </p:sp>
      <p:pic>
        <p:nvPicPr>
          <p:cNvPr id="7" name="Picture 6" descr="X-ray of a person's legs&#10;&#10;Description automatically generated">
            <a:extLst>
              <a:ext uri="{FF2B5EF4-FFF2-40B4-BE49-F238E27FC236}">
                <a16:creationId xmlns:a16="http://schemas.microsoft.com/office/drawing/2014/main" id="{0863E82A-4DD4-A5AF-9F4D-5D3B071CEC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9314" y="3204482"/>
            <a:ext cx="2476042" cy="3441603"/>
          </a:xfrm>
          <a:prstGeom prst="rect">
            <a:avLst/>
          </a:prstGeom>
        </p:spPr>
      </p:pic>
      <p:pic>
        <p:nvPicPr>
          <p:cNvPr id="8" name="Picture 7" descr="X-ray of a shoulder and arm&#10;&#10;Description automatically generated">
            <a:extLst>
              <a:ext uri="{FF2B5EF4-FFF2-40B4-BE49-F238E27FC236}">
                <a16:creationId xmlns:a16="http://schemas.microsoft.com/office/drawing/2014/main" id="{22435DCF-E973-9C14-0D20-41E91487948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7879" y="211915"/>
            <a:ext cx="3787477" cy="292594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15E26D7-1BCB-3A5C-B924-95967244C7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4704" y="1388129"/>
            <a:ext cx="2066723" cy="5023539"/>
          </a:xfrm>
          <a:prstGeom prst="rect">
            <a:avLst/>
          </a:prstGeom>
        </p:spPr>
      </p:pic>
      <p:pic>
        <p:nvPicPr>
          <p:cNvPr id="10" name="Picture 9" descr="X-ray of a person's arm&#10;&#10;Description automatically generated">
            <a:extLst>
              <a:ext uri="{FF2B5EF4-FFF2-40B4-BE49-F238E27FC236}">
                <a16:creationId xmlns:a16="http://schemas.microsoft.com/office/drawing/2014/main" id="{85144279-1AC6-4CC0-F2AF-153108E296F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6489" y="211915"/>
            <a:ext cx="3244022" cy="323503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B6098DF-9223-DABF-DA3F-654CA5E7D50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6489" y="3547825"/>
            <a:ext cx="1837632" cy="2863843"/>
          </a:xfrm>
          <a:prstGeom prst="rect">
            <a:avLst/>
          </a:prstGeom>
        </p:spPr>
      </p:pic>
      <p:pic>
        <p:nvPicPr>
          <p:cNvPr id="12" name="Picture 11" descr="X-ray of feet and toes&#10;&#10;Description automatically generated">
            <a:extLst>
              <a:ext uri="{FF2B5EF4-FFF2-40B4-BE49-F238E27FC236}">
                <a16:creationId xmlns:a16="http://schemas.microsoft.com/office/drawing/2014/main" id="{3CFFFF29-537A-694F-0C2F-D14F6E0E1A3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1854" y="3547825"/>
            <a:ext cx="2529727" cy="2863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91198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3321412-6F78-27CD-E57E-9EE9FC7D648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FFD708F-23CE-9611-B333-C214BD49DFCD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9FBD17-309C-84A4-CCE5-6F65349E9342}"/>
              </a:ext>
            </a:extLst>
          </p:cNvPr>
          <p:cNvSpPr txBox="1"/>
          <p:nvPr/>
        </p:nvSpPr>
        <p:spPr>
          <a:xfrm>
            <a:off x="3873490" y="5975740"/>
            <a:ext cx="7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8 </a:t>
            </a:r>
            <a:r>
              <a:rPr lang="en-US" dirty="0" err="1"/>
              <a:t>mo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77EDA9F-F514-22A4-638B-5707F6C6B0B9}"/>
              </a:ext>
            </a:extLst>
          </p:cNvPr>
          <p:cNvSpPr txBox="1"/>
          <p:nvPr/>
        </p:nvSpPr>
        <p:spPr>
          <a:xfrm>
            <a:off x="8537968" y="5975740"/>
            <a:ext cx="577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 yo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5B3F87-AA06-8146-9AA3-2917456CC9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834" t="10159" r="24404" b="5325"/>
          <a:stretch/>
        </p:blipFill>
        <p:spPr>
          <a:xfrm>
            <a:off x="1896716" y="804231"/>
            <a:ext cx="4731327" cy="50250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98AD51E-2EF0-143F-E972-7421010FFCA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8523" t="9091" r="28863" b="4448"/>
          <a:stretch/>
        </p:blipFill>
        <p:spPr>
          <a:xfrm>
            <a:off x="7664974" y="804231"/>
            <a:ext cx="2323905" cy="4997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8940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35EBECF-D285-BED8-00F8-A09FC359BC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435" y="776834"/>
            <a:ext cx="2279921" cy="494509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BCBE156-9CB3-0F2B-B943-E6E1C689AAB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341107" y="776831"/>
            <a:ext cx="2343459" cy="49450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AB279C0-1C4A-81A8-61BA-8C9E2C57434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21719" y="776832"/>
            <a:ext cx="2249958" cy="494509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98CEBE6-3861-0CFA-4A2C-728ACFDD0C0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32715" y="776832"/>
            <a:ext cx="2373645" cy="494509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A5C055C-2692-A5C7-DB27-502454C39765}"/>
              </a:ext>
            </a:extLst>
          </p:cNvPr>
          <p:cNvSpPr txBox="1"/>
          <p:nvPr/>
        </p:nvSpPr>
        <p:spPr>
          <a:xfrm>
            <a:off x="929928" y="5753377"/>
            <a:ext cx="694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7 </a:t>
            </a:r>
            <a:r>
              <a:rPr lang="en-US" dirty="0" err="1"/>
              <a:t>yo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3E9ADC8-C88A-3C72-F9B7-D1B5C2C99B83}"/>
              </a:ext>
            </a:extLst>
          </p:cNvPr>
          <p:cNvSpPr txBox="1"/>
          <p:nvPr/>
        </p:nvSpPr>
        <p:spPr>
          <a:xfrm>
            <a:off x="3272070" y="5753377"/>
            <a:ext cx="694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6 </a:t>
            </a:r>
            <a:r>
              <a:rPr lang="en-US" dirty="0" err="1"/>
              <a:t>yo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36810A-E4DE-97C6-0188-CEA445260AD0}"/>
              </a:ext>
            </a:extLst>
          </p:cNvPr>
          <p:cNvSpPr txBox="1"/>
          <p:nvPr/>
        </p:nvSpPr>
        <p:spPr>
          <a:xfrm>
            <a:off x="5599231" y="5753377"/>
            <a:ext cx="694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5 </a:t>
            </a:r>
            <a:r>
              <a:rPr lang="en-US" dirty="0" err="1"/>
              <a:t>yo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EC0CE7-5E6C-2369-0A21-9CE948332FA9}"/>
              </a:ext>
            </a:extLst>
          </p:cNvPr>
          <p:cNvSpPr txBox="1"/>
          <p:nvPr/>
        </p:nvSpPr>
        <p:spPr>
          <a:xfrm>
            <a:off x="9337099" y="5753377"/>
            <a:ext cx="694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 </a:t>
            </a:r>
            <a:r>
              <a:rPr lang="en-US" dirty="0" err="1"/>
              <a:t>yo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A07D2D-D69B-1DDE-4CBA-D06CF7580751}"/>
              </a:ext>
            </a:extLst>
          </p:cNvPr>
          <p:cNvSpPr txBox="1"/>
          <p:nvPr/>
        </p:nvSpPr>
        <p:spPr>
          <a:xfrm>
            <a:off x="212651" y="191386"/>
            <a:ext cx="11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 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704952-D10D-7D5C-E972-E59A186FA0C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684566" y="776832"/>
            <a:ext cx="2407234" cy="4945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1683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2D93225-7BC8-D0E9-3CAC-A1B347C6734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06" r="17028"/>
          <a:stretch/>
        </p:blipFill>
        <p:spPr>
          <a:xfrm>
            <a:off x="161149" y="185373"/>
            <a:ext cx="1257019" cy="3873059"/>
          </a:xfrm>
          <a:prstGeom prst="rect">
            <a:avLst/>
          </a:prstGeom>
          <a:ln w="76200">
            <a:noFill/>
          </a:ln>
        </p:spPr>
      </p:pic>
      <p:pic>
        <p:nvPicPr>
          <p:cNvPr id="9" name="Picture 8" descr="X-ray of a hip joint&#10;&#10;Description automatically generated">
            <a:extLst>
              <a:ext uri="{FF2B5EF4-FFF2-40B4-BE49-F238E27FC236}">
                <a16:creationId xmlns:a16="http://schemas.microsoft.com/office/drawing/2014/main" id="{EF564F85-DC45-B3B3-C7E4-BCC18FF446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4945"/>
          <a:stretch/>
        </p:blipFill>
        <p:spPr>
          <a:xfrm>
            <a:off x="1460363" y="185373"/>
            <a:ext cx="2141619" cy="1462559"/>
          </a:xfrm>
          <a:prstGeom prst="rect">
            <a:avLst/>
          </a:prstGeom>
          <a:ln w="76200"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17B2517-E3A8-B00F-4D5B-4BF45D5018C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56"/>
          <a:stretch/>
        </p:blipFill>
        <p:spPr>
          <a:xfrm flipH="1">
            <a:off x="3652639" y="185373"/>
            <a:ext cx="991617" cy="3857043"/>
          </a:xfrm>
          <a:prstGeom prst="rect">
            <a:avLst/>
          </a:prstGeom>
          <a:ln w="76200"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6B2BE6B-F861-3363-6C60-778D220F6D9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41687" y="1676509"/>
            <a:ext cx="2160296" cy="3305302"/>
          </a:xfrm>
          <a:prstGeom prst="rect">
            <a:avLst/>
          </a:prstGeom>
          <a:ln w="76200">
            <a:noFill/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47F332B5-7E8B-6370-2C22-1DF815E7728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878" t="1027" r="2506" b="1621"/>
          <a:stretch/>
        </p:blipFill>
        <p:spPr>
          <a:xfrm>
            <a:off x="9811678" y="2196918"/>
            <a:ext cx="1115373" cy="2396347"/>
          </a:xfrm>
          <a:prstGeom prst="rect">
            <a:avLst/>
          </a:prstGeom>
        </p:spPr>
      </p:pic>
      <p:pic>
        <p:nvPicPr>
          <p:cNvPr id="24" name="Picture 23" descr="X-ray of a person's body&#10;&#10;Description automatically generated">
            <a:extLst>
              <a:ext uri="{FF2B5EF4-FFF2-40B4-BE49-F238E27FC236}">
                <a16:creationId xmlns:a16="http://schemas.microsoft.com/office/drawing/2014/main" id="{AB08E78B-1186-B352-B99B-20E65D02C01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6129" y="185373"/>
            <a:ext cx="1039260" cy="3857043"/>
          </a:xfrm>
          <a:prstGeom prst="rect">
            <a:avLst/>
          </a:prstGeom>
        </p:spPr>
      </p:pic>
      <p:pic>
        <p:nvPicPr>
          <p:cNvPr id="25" name="Picture 24" descr="X-ray of a human arm&#10;&#10;Description automatically generated">
            <a:extLst>
              <a:ext uri="{FF2B5EF4-FFF2-40B4-BE49-F238E27FC236}">
                <a16:creationId xmlns:a16="http://schemas.microsoft.com/office/drawing/2014/main" id="{DEB1578C-6E2E-0441-3250-FA913FA3022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0141" y="4076744"/>
            <a:ext cx="2076626" cy="90506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3766756-4943-F04A-B38E-5A272B1104C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35682" t="8687" r="37272" b="3028"/>
          <a:stretch/>
        </p:blipFill>
        <p:spPr>
          <a:xfrm>
            <a:off x="5825355" y="2196918"/>
            <a:ext cx="2087541" cy="383309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FE362357-46A9-0F84-3F3E-D30A7049105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50000" t="9950" r="25348" b="4226"/>
          <a:stretch/>
        </p:blipFill>
        <p:spPr>
          <a:xfrm>
            <a:off x="5847262" y="196670"/>
            <a:ext cx="1005865" cy="196988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F65AB508-BCA9-DCF0-B280-43C1576F1C9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41136" t="9899" r="34773" b="6262"/>
          <a:stretch/>
        </p:blipFill>
        <p:spPr>
          <a:xfrm>
            <a:off x="6914710" y="185373"/>
            <a:ext cx="1006304" cy="196988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476C5BF3-DCFC-9167-1E0D-829B677B677E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48523" t="9091" r="28863" b="4448"/>
          <a:stretch/>
        </p:blipFill>
        <p:spPr>
          <a:xfrm>
            <a:off x="7972862" y="2196919"/>
            <a:ext cx="1782267" cy="383309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F7106241-9073-C250-DF70-8E0457469EB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988762" y="196670"/>
            <a:ext cx="805779" cy="1958590"/>
          </a:xfrm>
          <a:prstGeom prst="rect">
            <a:avLst/>
          </a:prstGeom>
        </p:spPr>
      </p:pic>
      <p:pic>
        <p:nvPicPr>
          <p:cNvPr id="31" name="Picture 30" descr="X-ray of a person's arm&#10;&#10;Description automatically generated">
            <a:extLst>
              <a:ext uri="{FF2B5EF4-FFF2-40B4-BE49-F238E27FC236}">
                <a16:creationId xmlns:a16="http://schemas.microsoft.com/office/drawing/2014/main" id="{FD004E5F-C981-EA27-CC2A-AE3DE0F6C8D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2289" y="196671"/>
            <a:ext cx="1964031" cy="1958590"/>
          </a:xfrm>
          <a:prstGeom prst="rect">
            <a:avLst/>
          </a:prstGeom>
        </p:spPr>
      </p:pic>
      <p:pic>
        <p:nvPicPr>
          <p:cNvPr id="32" name="Picture 31" descr="X-ray of feet with toes and toes&#10;&#10;Description automatically generated">
            <a:extLst>
              <a:ext uri="{FF2B5EF4-FFF2-40B4-BE49-F238E27FC236}">
                <a16:creationId xmlns:a16="http://schemas.microsoft.com/office/drawing/2014/main" id="{B8093AA5-F31B-9A1A-1E6E-6FA034C259BE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109"/>
          <a:stretch/>
        </p:blipFill>
        <p:spPr>
          <a:xfrm>
            <a:off x="4658517" y="5016139"/>
            <a:ext cx="1069417" cy="953456"/>
          </a:xfrm>
          <a:prstGeom prst="rect">
            <a:avLst/>
          </a:prstGeom>
        </p:spPr>
      </p:pic>
      <p:pic>
        <p:nvPicPr>
          <p:cNvPr id="33" name="Picture 32" descr="X-ray of hands and a book&#10;&#10;Description automatically generated">
            <a:extLst>
              <a:ext uri="{FF2B5EF4-FFF2-40B4-BE49-F238E27FC236}">
                <a16:creationId xmlns:a16="http://schemas.microsoft.com/office/drawing/2014/main" id="{AE5CAA46-726E-5ABE-E4DA-95CCAD41E9D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64"/>
          <a:stretch/>
        </p:blipFill>
        <p:spPr>
          <a:xfrm>
            <a:off x="3456374" y="5016139"/>
            <a:ext cx="603317" cy="950076"/>
          </a:xfrm>
          <a:prstGeom prst="rect">
            <a:avLst/>
          </a:prstGeom>
        </p:spPr>
      </p:pic>
      <p:pic>
        <p:nvPicPr>
          <p:cNvPr id="34" name="Picture 33" descr="X-ray of hands and a book&#10;&#10;Description automatically generated">
            <a:extLst>
              <a:ext uri="{FF2B5EF4-FFF2-40B4-BE49-F238E27FC236}">
                <a16:creationId xmlns:a16="http://schemas.microsoft.com/office/drawing/2014/main" id="{9996DC76-F871-2C64-EB4C-79D3925453BF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693"/>
          <a:stretch/>
        </p:blipFill>
        <p:spPr>
          <a:xfrm>
            <a:off x="4119657" y="5016139"/>
            <a:ext cx="478894" cy="964417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87699AC0-3085-6288-6207-6D8EA8AE106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 rot="5400000">
            <a:off x="11097441" y="-6704"/>
            <a:ext cx="728365" cy="1135114"/>
          </a:xfrm>
          <a:prstGeom prst="rect">
            <a:avLst/>
          </a:prstGeom>
        </p:spPr>
      </p:pic>
      <p:pic>
        <p:nvPicPr>
          <p:cNvPr id="36" name="Picture 35" descr="X-ray of feet and toes&#10;&#10;Description automatically generated">
            <a:extLst>
              <a:ext uri="{FF2B5EF4-FFF2-40B4-BE49-F238E27FC236}">
                <a16:creationId xmlns:a16="http://schemas.microsoft.com/office/drawing/2014/main" id="{FE7F4C3F-761E-4096-3F51-CCD427565C7C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13" b="22006"/>
          <a:stretch/>
        </p:blipFill>
        <p:spPr>
          <a:xfrm>
            <a:off x="10888077" y="1004080"/>
            <a:ext cx="1141104" cy="1095309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7A5E084D-6389-B539-E294-E8B9B98EC2D3}"/>
              </a:ext>
            </a:extLst>
          </p:cNvPr>
          <p:cNvSpPr txBox="1"/>
          <p:nvPr/>
        </p:nvSpPr>
        <p:spPr>
          <a:xfrm>
            <a:off x="1148223" y="8897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AF31D8A-469D-EC13-FC5E-851729397F38}"/>
              </a:ext>
            </a:extLst>
          </p:cNvPr>
          <p:cNvSpPr txBox="1"/>
          <p:nvPr/>
        </p:nvSpPr>
        <p:spPr>
          <a:xfrm>
            <a:off x="1439858" y="124180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7EB7937-DE32-B75F-5203-706B833E29E3}"/>
              </a:ext>
            </a:extLst>
          </p:cNvPr>
          <p:cNvSpPr txBox="1"/>
          <p:nvPr/>
        </p:nvSpPr>
        <p:spPr>
          <a:xfrm>
            <a:off x="1424231" y="1676138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B4E5199-F6C3-8218-1BB6-148E90F0FC1B}"/>
              </a:ext>
            </a:extLst>
          </p:cNvPr>
          <p:cNvSpPr txBox="1"/>
          <p:nvPr/>
        </p:nvSpPr>
        <p:spPr>
          <a:xfrm>
            <a:off x="4354964" y="15042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00AB375-6E8A-6447-1AAD-753CEEE9699A}"/>
              </a:ext>
            </a:extLst>
          </p:cNvPr>
          <p:cNvSpPr txBox="1"/>
          <p:nvPr/>
        </p:nvSpPr>
        <p:spPr>
          <a:xfrm>
            <a:off x="5426034" y="88974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EF79743-B17C-87EA-2412-5322E65D6AC5}"/>
              </a:ext>
            </a:extLst>
          </p:cNvPr>
          <p:cNvSpPr txBox="1"/>
          <p:nvPr/>
        </p:nvSpPr>
        <p:spPr>
          <a:xfrm>
            <a:off x="5424237" y="404241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DDF6D4A-EE6C-0E7C-A8C8-07E84CF0F755}"/>
              </a:ext>
            </a:extLst>
          </p:cNvPr>
          <p:cNvSpPr txBox="1"/>
          <p:nvPr/>
        </p:nvSpPr>
        <p:spPr>
          <a:xfrm>
            <a:off x="3396408" y="55993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0BFCED2-A5A1-5DBD-A83A-642494E09479}"/>
              </a:ext>
            </a:extLst>
          </p:cNvPr>
          <p:cNvSpPr txBox="1"/>
          <p:nvPr/>
        </p:nvSpPr>
        <p:spPr>
          <a:xfrm>
            <a:off x="4345799" y="559688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6D9391F-4A79-6D5B-FB40-C7656BEE13BE}"/>
              </a:ext>
            </a:extLst>
          </p:cNvPr>
          <p:cNvSpPr txBox="1"/>
          <p:nvPr/>
        </p:nvSpPr>
        <p:spPr>
          <a:xfrm>
            <a:off x="4644256" y="4937179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E19CC50-5AF3-ECCD-4846-77913F8C00BA}"/>
              </a:ext>
            </a:extLst>
          </p:cNvPr>
          <p:cNvSpPr txBox="1"/>
          <p:nvPr/>
        </p:nvSpPr>
        <p:spPr>
          <a:xfrm>
            <a:off x="6619388" y="150427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81FCF01-7A24-90A3-12DC-1E4C5C09E31A}"/>
              </a:ext>
            </a:extLst>
          </p:cNvPr>
          <p:cNvSpPr txBox="1"/>
          <p:nvPr/>
        </p:nvSpPr>
        <p:spPr>
          <a:xfrm>
            <a:off x="7584758" y="15042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417C8E8-C760-D9AE-C3EA-550BB4B20220}"/>
              </a:ext>
            </a:extLst>
          </p:cNvPr>
          <p:cNvSpPr txBox="1"/>
          <p:nvPr/>
        </p:nvSpPr>
        <p:spPr>
          <a:xfrm>
            <a:off x="5847262" y="219691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C6C1702-94A0-4928-A65E-6068D5A26A39}"/>
              </a:ext>
            </a:extLst>
          </p:cNvPr>
          <p:cNvSpPr txBox="1"/>
          <p:nvPr/>
        </p:nvSpPr>
        <p:spPr>
          <a:xfrm>
            <a:off x="8441288" y="1816472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9BA6D6B-6D58-0071-FEB0-1864F52F5307}"/>
              </a:ext>
            </a:extLst>
          </p:cNvPr>
          <p:cNvSpPr txBox="1"/>
          <p:nvPr/>
        </p:nvSpPr>
        <p:spPr>
          <a:xfrm>
            <a:off x="7967550" y="214864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142ECE4-D8C7-E8D7-F161-6BCF14107FA0}"/>
              </a:ext>
            </a:extLst>
          </p:cNvPr>
          <p:cNvSpPr txBox="1"/>
          <p:nvPr/>
        </p:nvSpPr>
        <p:spPr>
          <a:xfrm>
            <a:off x="10467640" y="18177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EB24242-5438-76F9-C3D1-B0AE0C9FEDA4}"/>
              </a:ext>
            </a:extLst>
          </p:cNvPr>
          <p:cNvSpPr txBox="1"/>
          <p:nvPr/>
        </p:nvSpPr>
        <p:spPr>
          <a:xfrm>
            <a:off x="10872486" y="5540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B5472FE-0749-8B7E-8926-4BB084E84548}"/>
              </a:ext>
            </a:extLst>
          </p:cNvPr>
          <p:cNvSpPr txBox="1"/>
          <p:nvPr/>
        </p:nvSpPr>
        <p:spPr>
          <a:xfrm>
            <a:off x="11750679" y="8808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4586316-89CA-983E-67E8-7E0A23021E0D}"/>
              </a:ext>
            </a:extLst>
          </p:cNvPr>
          <p:cNvSpPr txBox="1"/>
          <p:nvPr/>
        </p:nvSpPr>
        <p:spPr>
          <a:xfrm>
            <a:off x="9776341" y="211980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B1165D7-0538-D2D1-9EEC-DFEBE10FE175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8328" r="6481"/>
          <a:stretch/>
        </p:blipFill>
        <p:spPr>
          <a:xfrm>
            <a:off x="10983600" y="2196917"/>
            <a:ext cx="993775" cy="2396347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F926D2A8-F37C-0F0E-67C7-958BA5AD1850}"/>
              </a:ext>
            </a:extLst>
          </p:cNvPr>
          <p:cNvSpPr txBox="1"/>
          <p:nvPr/>
        </p:nvSpPr>
        <p:spPr>
          <a:xfrm>
            <a:off x="11750679" y="2118071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CBF23D6-640C-3393-4BAB-7BB51A35D046}"/>
              </a:ext>
            </a:extLst>
          </p:cNvPr>
          <p:cNvSpPr txBox="1"/>
          <p:nvPr/>
        </p:nvSpPr>
        <p:spPr>
          <a:xfrm>
            <a:off x="122912" y="6303295"/>
            <a:ext cx="19953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 Composite</a:t>
            </a:r>
          </a:p>
        </p:txBody>
      </p:sp>
    </p:spTree>
    <p:extLst>
      <p:ext uri="{BB962C8B-B14F-4D97-AF65-F5344CB8AC3E}">
        <p14:creationId xmlns:p14="http://schemas.microsoft.com/office/powerpoint/2010/main" val="4030552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3</TotalTime>
  <Words>308</Words>
  <Application>Microsoft Macintosh PowerPoint</Application>
  <PresentationFormat>Widescreen</PresentationFormat>
  <Paragraphs>60</Paragraphs>
  <Slides>9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CIDFont+F2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Gayle Tise</dc:creator>
  <cp:lastModifiedBy>Christina Gayle Tise</cp:lastModifiedBy>
  <cp:revision>14</cp:revision>
  <dcterms:created xsi:type="dcterms:W3CDTF">2023-10-08T16:26:42Z</dcterms:created>
  <dcterms:modified xsi:type="dcterms:W3CDTF">2024-04-25T20:59:14Z</dcterms:modified>
</cp:coreProperties>
</file>